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8E368D-2F77-4FA6-9D23-8C4352788C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C87613-AC73-4765-9CF7-4B59D4C5EF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4B5CD-8F2F-423B-AF19-A2A6AC3376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C2ACF-9862-48DF-B36E-EDA0393AEB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01B8A3-39AE-4082-866D-78504C05F1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68C3DD-6CFE-4022-A297-6037338952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2CFF8-1B01-42A8-9E13-E444EF65B7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3857C0-4334-4A20-96D6-3D35B56D8D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6B42A-2024-4DCE-82F8-15829F6570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E79099-2A73-4E75-A167-3517140604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D684AA-BB5E-49AF-8286-8197B7A96F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8424CE-D2E4-451F-9A27-5B2D9E7FAA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5C6A1B-5236-4577-BA6D-7C741F6009E0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192"/>
          <p:cNvSpPr/>
          <p:nvPr/>
        </p:nvSpPr>
        <p:spPr>
          <a:xfrm>
            <a:off x="4610160" y="4284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474"/>
          <p:cNvSpPr/>
          <p:nvPr/>
        </p:nvSpPr>
        <p:spPr>
          <a:xfrm>
            <a:off x="620640" y="98100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474"/>
          <p:cNvSpPr/>
          <p:nvPr/>
        </p:nvSpPr>
        <p:spPr>
          <a:xfrm>
            <a:off x="620640" y="399564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474"/>
          <p:cNvSpPr/>
          <p:nvPr/>
        </p:nvSpPr>
        <p:spPr>
          <a:xfrm>
            <a:off x="3284640" y="98100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5" name="Grafico 24"/>
          <p:cNvGraphicFramePr/>
          <p:nvPr/>
        </p:nvGraphicFramePr>
        <p:xfrm>
          <a:off x="4021200" y="1065240"/>
          <a:ext cx="2674800" cy="18273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6" name="Grafico 2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021200" y="1065240"/>
                    <a:ext cx="2674800" cy="1827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47" name="Gruppo 26"/>
          <p:cNvGrpSpPr/>
          <p:nvPr/>
        </p:nvGrpSpPr>
        <p:grpSpPr>
          <a:xfrm>
            <a:off x="3470040" y="2786040"/>
            <a:ext cx="2124720" cy="630360"/>
            <a:chOff x="3470040" y="2786040"/>
            <a:chExt cx="2124720" cy="630360"/>
          </a:xfrm>
        </p:grpSpPr>
        <p:sp>
          <p:nvSpPr>
            <p:cNvPr id="48" name="CasellaDiTesto 7"/>
            <p:cNvSpPr/>
            <p:nvPr/>
          </p:nvSpPr>
          <p:spPr>
            <a:xfrm>
              <a:off x="3470040" y="2786040"/>
              <a:ext cx="90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CDDP (5 µg/ml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CasellaDiTesto 8"/>
            <p:cNvSpPr/>
            <p:nvPr/>
          </p:nvSpPr>
          <p:spPr>
            <a:xfrm>
              <a:off x="4372920" y="2786040"/>
              <a:ext cx="1213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-       +       +        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CasellaDiTesto 9"/>
            <p:cNvSpPr/>
            <p:nvPr/>
          </p:nvSpPr>
          <p:spPr>
            <a:xfrm>
              <a:off x="3978360" y="2985840"/>
              <a:ext cx="39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NA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CasellaDiTesto 10"/>
            <p:cNvSpPr/>
            <p:nvPr/>
          </p:nvSpPr>
          <p:spPr>
            <a:xfrm>
              <a:off x="4367160" y="2985840"/>
              <a:ext cx="1218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-       -        +        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CasellaDiTesto 11"/>
            <p:cNvSpPr/>
            <p:nvPr/>
          </p:nvSpPr>
          <p:spPr>
            <a:xfrm>
              <a:off x="3709800" y="3170160"/>
              <a:ext cx="65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SB20219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CasellaDiTesto 12"/>
            <p:cNvSpPr/>
            <p:nvPr/>
          </p:nvSpPr>
          <p:spPr>
            <a:xfrm>
              <a:off x="4371480" y="3170160"/>
              <a:ext cx="122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-       -        -         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4" name="CasellaDiTesto 42"/>
          <p:cNvSpPr/>
          <p:nvPr/>
        </p:nvSpPr>
        <p:spPr>
          <a:xfrm>
            <a:off x="4726800" y="105876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iPrE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5" name="Gruppo 3"/>
          <p:cNvGrpSpPr/>
          <p:nvPr/>
        </p:nvGrpSpPr>
        <p:grpSpPr>
          <a:xfrm>
            <a:off x="695160" y="2698920"/>
            <a:ext cx="1668240" cy="630360"/>
            <a:chOff x="695160" y="2698920"/>
            <a:chExt cx="1668240" cy="630360"/>
          </a:xfrm>
        </p:grpSpPr>
        <p:sp>
          <p:nvSpPr>
            <p:cNvPr id="56" name="CasellaDiTesto 7"/>
            <p:cNvSpPr/>
            <p:nvPr/>
          </p:nvSpPr>
          <p:spPr>
            <a:xfrm>
              <a:off x="695160" y="2698920"/>
              <a:ext cx="90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CDDP (5 µg/ml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CasellaDiTesto 8"/>
            <p:cNvSpPr/>
            <p:nvPr/>
          </p:nvSpPr>
          <p:spPr>
            <a:xfrm>
              <a:off x="1597320" y="2698920"/>
              <a:ext cx="758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-   +   +   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CasellaDiTesto 9"/>
            <p:cNvSpPr/>
            <p:nvPr/>
          </p:nvSpPr>
          <p:spPr>
            <a:xfrm>
              <a:off x="1203840" y="2898720"/>
              <a:ext cx="39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NA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CasellaDiTesto 10"/>
            <p:cNvSpPr/>
            <p:nvPr/>
          </p:nvSpPr>
          <p:spPr>
            <a:xfrm>
              <a:off x="1591560" y="2898720"/>
              <a:ext cx="76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-    -   +   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CasellaDiTesto 11"/>
            <p:cNvSpPr/>
            <p:nvPr/>
          </p:nvSpPr>
          <p:spPr>
            <a:xfrm>
              <a:off x="935640" y="3083040"/>
              <a:ext cx="65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SB20219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CasellaDiTesto 12"/>
            <p:cNvSpPr/>
            <p:nvPr/>
          </p:nvSpPr>
          <p:spPr>
            <a:xfrm>
              <a:off x="1595880" y="3083040"/>
              <a:ext cx="767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-    -    -   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2" name="Gruppo 20"/>
          <p:cNvGrpSpPr/>
          <p:nvPr/>
        </p:nvGrpSpPr>
        <p:grpSpPr>
          <a:xfrm>
            <a:off x="814320" y="4356000"/>
            <a:ext cx="1944720" cy="1511280"/>
            <a:chOff x="814320" y="4356000"/>
            <a:chExt cx="1944720" cy="1511280"/>
          </a:xfrm>
        </p:grpSpPr>
        <p:grpSp>
          <p:nvGrpSpPr>
            <p:cNvPr id="63" name="Rettangolo arrotondato 18"/>
            <p:cNvGrpSpPr/>
            <p:nvPr/>
          </p:nvGrpSpPr>
          <p:grpSpPr>
            <a:xfrm>
              <a:off x="914040" y="4356000"/>
              <a:ext cx="1694880" cy="1511280"/>
              <a:chOff x="914040" y="4356000"/>
              <a:chExt cx="1694880" cy="1511280"/>
            </a:xfrm>
          </p:grpSpPr>
          <p:pic>
            <p:nvPicPr>
              <p:cNvPr id="64" name="Rettangolo arrotondato 18" descr=""/>
              <p:cNvPicPr/>
              <p:nvPr/>
            </p:nvPicPr>
            <p:blipFill>
              <a:blip r:embed="rId3"/>
              <a:stretch/>
            </p:blipFill>
            <p:spPr>
              <a:xfrm>
                <a:off x="914040" y="4356000"/>
                <a:ext cx="1694880" cy="1511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5" name=""/>
              <p:cNvSpPr/>
              <p:nvPr/>
            </p:nvSpPr>
            <p:spPr>
              <a:xfrm>
                <a:off x="1046520" y="4450320"/>
                <a:ext cx="1424520" cy="126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6" name="Gruppo 16"/>
            <p:cNvGrpSpPr/>
            <p:nvPr/>
          </p:nvGrpSpPr>
          <p:grpSpPr>
            <a:xfrm>
              <a:off x="814320" y="4582080"/>
              <a:ext cx="1944720" cy="1105920"/>
              <a:chOff x="814320" y="4582080"/>
              <a:chExt cx="1944720" cy="1105920"/>
            </a:xfrm>
          </p:grpSpPr>
          <p:sp>
            <p:nvSpPr>
              <p:cNvPr id="67" name="CasellaDiTesto 36"/>
              <p:cNvSpPr/>
              <p:nvPr/>
            </p:nvSpPr>
            <p:spPr>
              <a:xfrm>
                <a:off x="814320" y="4853880"/>
                <a:ext cx="1152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RO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CasellaDiTesto 6"/>
              <p:cNvSpPr/>
              <p:nvPr/>
            </p:nvSpPr>
            <p:spPr>
              <a:xfrm>
                <a:off x="1185480" y="4582080"/>
                <a:ext cx="1152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</a:rPr>
                  <a:t>CDDP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CasellaDiTesto 37"/>
              <p:cNvSpPr/>
              <p:nvPr/>
            </p:nvSpPr>
            <p:spPr>
              <a:xfrm>
                <a:off x="1606680" y="4854600"/>
                <a:ext cx="1152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Pp3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CasellaDiTesto 38"/>
              <p:cNvSpPr/>
              <p:nvPr/>
            </p:nvSpPr>
            <p:spPr>
              <a:xfrm>
                <a:off x="1181520" y="5224680"/>
                <a:ext cx="1152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Caspase-3 cleavag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Freccia curva 8"/>
              <p:cNvSpPr/>
              <p:nvPr/>
            </p:nvSpPr>
            <p:spPr>
              <a:xfrm rot="5400000">
                <a:off x="2074320" y="4628520"/>
                <a:ext cx="142920" cy="215640"/>
              </a:xfrm>
              <a:custGeom>
                <a:avLst/>
                <a:gdLst/>
                <a:ahLst/>
                <a:rect l="l" t="t" r="r" b="b"/>
                <a:pathLst>
                  <a:path w="154076" h="215848">
                    <a:moveTo>
                      <a:pt x="0" y="215848"/>
                    </a:moveTo>
                    <a:lnTo>
                      <a:pt x="0" y="86668"/>
                    </a:lnTo>
                    <a:cubicBezTo>
                      <a:pt x="0" y="49440"/>
                      <a:pt x="30180" y="19260"/>
                      <a:pt x="67408" y="19260"/>
                    </a:cubicBezTo>
                    <a:lnTo>
                      <a:pt x="115557" y="19260"/>
                    </a:lnTo>
                    <a:lnTo>
                      <a:pt x="115557" y="0"/>
                    </a:lnTo>
                    <a:lnTo>
                      <a:pt x="154076" y="38519"/>
                    </a:lnTo>
                    <a:lnTo>
                      <a:pt x="115557" y="77038"/>
                    </a:lnTo>
                    <a:lnTo>
                      <a:pt x="115557" y="57779"/>
                    </a:lnTo>
                    <a:lnTo>
                      <a:pt x="67408" y="57779"/>
                    </a:lnTo>
                    <a:cubicBezTo>
                      <a:pt x="51453" y="57779"/>
                      <a:pt x="38519" y="70713"/>
                      <a:pt x="38519" y="86668"/>
                    </a:cubicBezTo>
                    <a:lnTo>
                      <a:pt x="38519" y="215848"/>
                    </a:lnTo>
                    <a:lnTo>
                      <a:pt x="0" y="215848"/>
                    </a:lnTo>
                    <a:close/>
                  </a:path>
                </a:pathLst>
              </a:custGeom>
              <a:solidFill>
                <a:srgbClr val="0000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Freccia curva 48"/>
              <p:cNvSpPr/>
              <p:nvPr/>
            </p:nvSpPr>
            <p:spPr>
              <a:xfrm flipH="1" rot="16200000">
                <a:off x="1344600" y="4618800"/>
                <a:ext cx="125280" cy="217440"/>
              </a:xfrm>
              <a:custGeom>
                <a:avLst/>
                <a:gdLst/>
                <a:ahLst/>
                <a:rect l="l" t="t" r="r" b="b"/>
                <a:pathLst>
                  <a:path w="135016" h="217435">
                    <a:moveTo>
                      <a:pt x="0" y="217435"/>
                    </a:moveTo>
                    <a:lnTo>
                      <a:pt x="0" y="75947"/>
                    </a:lnTo>
                    <a:cubicBezTo>
                      <a:pt x="0" y="43324"/>
                      <a:pt x="26447" y="16877"/>
                      <a:pt x="59070" y="16877"/>
                    </a:cubicBezTo>
                    <a:lnTo>
                      <a:pt x="101262" y="16877"/>
                    </a:lnTo>
                    <a:lnTo>
                      <a:pt x="101262" y="0"/>
                    </a:lnTo>
                    <a:lnTo>
                      <a:pt x="135016" y="33754"/>
                    </a:lnTo>
                    <a:lnTo>
                      <a:pt x="101262" y="67508"/>
                    </a:lnTo>
                    <a:lnTo>
                      <a:pt x="101262" y="50631"/>
                    </a:lnTo>
                    <a:lnTo>
                      <a:pt x="59070" y="50631"/>
                    </a:lnTo>
                    <a:cubicBezTo>
                      <a:pt x="45088" y="50631"/>
                      <a:pt x="33754" y="61965"/>
                      <a:pt x="33754" y="75947"/>
                    </a:cubicBezTo>
                    <a:lnTo>
                      <a:pt x="33754" y="217435"/>
                    </a:lnTo>
                    <a:lnTo>
                      <a:pt x="0" y="217435"/>
                    </a:lnTo>
                    <a:close/>
                  </a:path>
                </a:pathLst>
              </a:custGeom>
              <a:solidFill>
                <a:srgbClr val="0000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Freccia a destra 10"/>
              <p:cNvSpPr/>
              <p:nvPr/>
            </p:nvSpPr>
            <p:spPr>
              <a:xfrm>
                <a:off x="1517400" y="4943520"/>
                <a:ext cx="468360" cy="42480"/>
              </a:xfrm>
              <a:prstGeom prst="rightArrow">
                <a:avLst>
                  <a:gd name="adj1" fmla="val 50000"/>
                  <a:gd name="adj2" fmla="val 54259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74" name="Gruppo 14"/>
              <p:cNvGrpSpPr/>
              <p:nvPr/>
            </p:nvGrpSpPr>
            <p:grpSpPr>
              <a:xfrm>
                <a:off x="1213560" y="5404320"/>
                <a:ext cx="1152360" cy="283680"/>
                <a:chOff x="1213560" y="5404320"/>
                <a:chExt cx="1152360" cy="283680"/>
              </a:xfrm>
            </p:grpSpPr>
            <p:sp>
              <p:nvSpPr>
                <p:cNvPr id="75" name="CasellaDiTesto 40"/>
                <p:cNvSpPr/>
                <p:nvPr/>
              </p:nvSpPr>
              <p:spPr>
                <a:xfrm>
                  <a:off x="1213560" y="5472360"/>
                  <a:ext cx="1152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800" spc="-1" strike="noStrike">
                      <a:solidFill>
                        <a:srgbClr val="000000"/>
                      </a:solidFill>
                      <a:latin typeface="Arial"/>
                    </a:rPr>
                    <a:t>Apoptosis 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" name="Triangolo isoscele 11"/>
                <p:cNvSpPr/>
                <p:nvPr/>
              </p:nvSpPr>
              <p:spPr>
                <a:xfrm rot="10800000">
                  <a:off x="1698120" y="5404320"/>
                  <a:ext cx="96840" cy="7128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000000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7" name="Freccia in giù 13"/>
              <p:cNvSpPr/>
              <p:nvPr/>
            </p:nvSpPr>
            <p:spPr>
              <a:xfrm>
                <a:off x="1295280" y="5033520"/>
                <a:ext cx="56880" cy="200520"/>
              </a:xfrm>
              <a:prstGeom prst="downArrow">
                <a:avLst>
                  <a:gd name="adj1" fmla="val 50000"/>
                  <a:gd name="adj2" fmla="val 46612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Freccia in giù 53"/>
              <p:cNvSpPr/>
              <p:nvPr/>
            </p:nvSpPr>
            <p:spPr>
              <a:xfrm>
                <a:off x="2143080" y="5033520"/>
                <a:ext cx="56880" cy="200520"/>
              </a:xfrm>
              <a:prstGeom prst="downArrow">
                <a:avLst>
                  <a:gd name="adj1" fmla="val 50000"/>
                  <a:gd name="adj2" fmla="val 46612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79" name="Gruppo 7"/>
          <p:cNvGrpSpPr/>
          <p:nvPr/>
        </p:nvGrpSpPr>
        <p:grpSpPr>
          <a:xfrm>
            <a:off x="1581120" y="1305000"/>
            <a:ext cx="1101600" cy="458640"/>
            <a:chOff x="1581120" y="1305000"/>
            <a:chExt cx="1101600" cy="458640"/>
          </a:xfrm>
        </p:grpSpPr>
        <p:pic>
          <p:nvPicPr>
            <p:cNvPr id="80" name="Picture 2" descr=""/>
            <p:cNvPicPr/>
            <p:nvPr/>
          </p:nvPicPr>
          <p:blipFill>
            <a:blip r:embed="rId4"/>
            <a:stretch/>
          </p:blipFill>
          <p:spPr>
            <a:xfrm>
              <a:off x="1581120" y="1305000"/>
              <a:ext cx="756720" cy="21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" name="Text Box 477"/>
            <p:cNvSpPr/>
            <p:nvPr/>
          </p:nvSpPr>
          <p:spPr>
            <a:xfrm>
              <a:off x="2296080" y="1305000"/>
              <a:ext cx="38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Pp38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Rectangle 479"/>
            <p:cNvSpPr/>
            <p:nvPr/>
          </p:nvSpPr>
          <p:spPr>
            <a:xfrm>
              <a:off x="2296800" y="1536480"/>
              <a:ext cx="351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p38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3" name="Picture 21" descr=""/>
            <p:cNvPicPr/>
            <p:nvPr/>
          </p:nvPicPr>
          <p:blipFill>
            <a:blip r:embed="rId5"/>
            <a:stretch/>
          </p:blipFill>
          <p:spPr>
            <a:xfrm>
              <a:off x="1581120" y="1547640"/>
              <a:ext cx="756720" cy="2160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84" name="Gruppo 3"/>
          <p:cNvGrpSpPr/>
          <p:nvPr/>
        </p:nvGrpSpPr>
        <p:grpSpPr>
          <a:xfrm>
            <a:off x="1581120" y="2252520"/>
            <a:ext cx="1164600" cy="449280"/>
            <a:chOff x="1581120" y="2252520"/>
            <a:chExt cx="1164600" cy="449280"/>
          </a:xfrm>
        </p:grpSpPr>
        <p:sp>
          <p:nvSpPr>
            <p:cNvPr id="85" name="Rectangle 479"/>
            <p:cNvSpPr/>
            <p:nvPr/>
          </p:nvSpPr>
          <p:spPr>
            <a:xfrm>
              <a:off x="2281320" y="2485440"/>
              <a:ext cx="444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 Box 477"/>
            <p:cNvSpPr/>
            <p:nvPr/>
          </p:nvSpPr>
          <p:spPr>
            <a:xfrm>
              <a:off x="2278440" y="2256480"/>
              <a:ext cx="467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cPARP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7" name="Picture 3" descr=""/>
            <p:cNvPicPr/>
            <p:nvPr/>
          </p:nvPicPr>
          <p:blipFill>
            <a:blip r:embed="rId6"/>
            <a:stretch/>
          </p:blipFill>
          <p:spPr>
            <a:xfrm>
              <a:off x="1581120" y="2485440"/>
              <a:ext cx="755280" cy="21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22" descr=""/>
            <p:cNvPicPr/>
            <p:nvPr/>
          </p:nvPicPr>
          <p:blipFill>
            <a:blip r:embed="rId7"/>
            <a:stretch/>
          </p:blipFill>
          <p:spPr>
            <a:xfrm>
              <a:off x="1581120" y="2252520"/>
              <a:ext cx="755640" cy="216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9" name="CasellaDiTesto 1"/>
          <p:cNvSpPr/>
          <p:nvPr/>
        </p:nvSpPr>
        <p:spPr>
          <a:xfrm>
            <a:off x="1728000" y="105876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iPrE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0" name="Gruppo 2"/>
          <p:cNvGrpSpPr/>
          <p:nvPr/>
        </p:nvGrpSpPr>
        <p:grpSpPr>
          <a:xfrm>
            <a:off x="1577880" y="1820880"/>
            <a:ext cx="1324800" cy="360000"/>
            <a:chOff x="1577880" y="1820880"/>
            <a:chExt cx="1324800" cy="360000"/>
          </a:xfrm>
        </p:grpSpPr>
        <p:pic>
          <p:nvPicPr>
            <p:cNvPr id="91" name="Picture 24" descr=""/>
            <p:cNvPicPr/>
            <p:nvPr/>
          </p:nvPicPr>
          <p:blipFill>
            <a:blip r:embed="rId8"/>
            <a:stretch/>
          </p:blipFill>
          <p:spPr>
            <a:xfrm flipH="1" rot="16200000">
              <a:off x="1881720" y="1542240"/>
              <a:ext cx="148320" cy="756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2" name="Text Box 477"/>
            <p:cNvSpPr/>
            <p:nvPr/>
          </p:nvSpPr>
          <p:spPr>
            <a:xfrm>
              <a:off x="2281680" y="1820880"/>
              <a:ext cx="621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ProCasp_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3" name="Picture 56" descr=""/>
            <p:cNvPicPr/>
            <p:nvPr/>
          </p:nvPicPr>
          <p:blipFill>
            <a:blip r:embed="rId9"/>
            <a:stretch/>
          </p:blipFill>
          <p:spPr>
            <a:xfrm>
              <a:off x="1584000" y="2012760"/>
              <a:ext cx="743760" cy="167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Text Box 477"/>
            <p:cNvSpPr/>
            <p:nvPr/>
          </p:nvSpPr>
          <p:spPr>
            <a:xfrm>
              <a:off x="2280960" y="1980360"/>
              <a:ext cx="528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cCasp_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5" name="CasellaDiTesto 1"/>
          <p:cNvSpPr/>
          <p:nvPr/>
        </p:nvSpPr>
        <p:spPr>
          <a:xfrm>
            <a:off x="476280" y="6488280"/>
            <a:ext cx="5761080" cy="1769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2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OS generation and p38 activation cross-talk in the CDDP-induced apoptosi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Western blot analysis of p38, caspase-3 and PARP activation, and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evaluation of both ROS generation and apoptosis by flow-cytometry, performed in the iPrEC cells undergoing treatment with 5 µg/ml CDDP. Where indicated, cells have been pre-loaded with SB202190 (10 µM)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nd/or NAC (5mM) agents.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Schematic representation of the ROS and p38 involvement in the death cascade elicited by high dose of CDDP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28T09:42:29Z</dcterms:created>
  <dc:creator>BarbaraB</dc:creator>
  <dc:description/>
  <dc:language>en-US</dc:language>
  <cp:lastModifiedBy>BarbaraB</cp:lastModifiedBy>
  <cp:lastPrinted>2013-05-31T10:18:25Z</cp:lastPrinted>
  <dcterms:modified xsi:type="dcterms:W3CDTF">2013-06-12T11:53:09Z</dcterms:modified>
  <cp:revision>30</cp:revision>
  <dc:subject/>
  <dc:title>Presentazione standard di PowerPoint</dc:title>
</cp:coreProperties>
</file>